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0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738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nna Johnsson" userId="ef1be37a-598e-4638-b9ed-50fc583bda9b" providerId="ADAL" clId="{66D5BF6E-2C9C-4454-A2E4-5BBB05E04C12}"/>
    <pc:docChg chg="modSld">
      <pc:chgData name="Hanna Johnsson" userId="ef1be37a-598e-4638-b9ed-50fc583bda9b" providerId="ADAL" clId="{66D5BF6E-2C9C-4454-A2E4-5BBB05E04C12}" dt="2022-11-08T12:17:31.794" v="16" actId="20577"/>
      <pc:docMkLst>
        <pc:docMk/>
      </pc:docMkLst>
      <pc:sldChg chg="modSp mod">
        <pc:chgData name="Hanna Johnsson" userId="ef1be37a-598e-4638-b9ed-50fc583bda9b" providerId="ADAL" clId="{66D5BF6E-2C9C-4454-A2E4-5BBB05E04C12}" dt="2022-11-08T12:17:31.794" v="16" actId="20577"/>
        <pc:sldMkLst>
          <pc:docMk/>
          <pc:sldMk cId="963384149" sldId="271"/>
        </pc:sldMkLst>
        <pc:spChg chg="mod">
          <ac:chgData name="Hanna Johnsson" userId="ef1be37a-598e-4638-b9ed-50fc583bda9b" providerId="ADAL" clId="{66D5BF6E-2C9C-4454-A2E4-5BBB05E04C12}" dt="2022-11-08T12:17:31.794" v="16" actId="20577"/>
          <ac:spMkLst>
            <pc:docMk/>
            <pc:sldMk cId="963384149" sldId="271"/>
            <ac:spMk id="7" creationId="{873CBEA4-9E8E-B2CE-5600-839748932E6F}"/>
          </ac:spMkLst>
        </pc:spChg>
      </pc:sldChg>
    </pc:docChg>
  </pc:docChgLst>
  <pc:docChgLst>
    <pc:chgData name="Hanna Johnsson" userId="ef1be37a-598e-4638-b9ed-50fc583bda9b" providerId="ADAL" clId="{8C80CD55-ABFE-4761-8D49-4323F3FCBF9D}"/>
    <pc:docChg chg="modSld">
      <pc:chgData name="Hanna Johnsson" userId="ef1be37a-598e-4638-b9ed-50fc583bda9b" providerId="ADAL" clId="{8C80CD55-ABFE-4761-8D49-4323F3FCBF9D}" dt="2022-08-11T21:15:08.197" v="0" actId="20577"/>
      <pc:docMkLst>
        <pc:docMk/>
      </pc:docMkLst>
      <pc:sldChg chg="modSp mod">
        <pc:chgData name="Hanna Johnsson" userId="ef1be37a-598e-4638-b9ed-50fc583bda9b" providerId="ADAL" clId="{8C80CD55-ABFE-4761-8D49-4323F3FCBF9D}" dt="2022-08-11T21:15:08.197" v="0" actId="20577"/>
        <pc:sldMkLst>
          <pc:docMk/>
          <pc:sldMk cId="963384149" sldId="271"/>
        </pc:sldMkLst>
        <pc:spChg chg="mod">
          <ac:chgData name="Hanna Johnsson" userId="ef1be37a-598e-4638-b9ed-50fc583bda9b" providerId="ADAL" clId="{8C80CD55-ABFE-4761-8D49-4323F3FCBF9D}" dt="2022-08-11T21:15:08.197" v="0" actId="20577"/>
          <ac:spMkLst>
            <pc:docMk/>
            <pc:sldMk cId="963384149" sldId="271"/>
            <ac:spMk id="7" creationId="{873CBEA4-9E8E-B2CE-5600-839748932E6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69EF24-6E63-1EC0-3B1B-A077A3B831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A81F1B-24F1-C139-1832-D8579F5E80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0EC012-45DF-D9AB-55B2-F8F1984516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D890C-6C35-44B3-8124-D1716A840C6B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ACA3D3-D5FE-7295-2203-023D518677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A0618F-DF74-28D2-15B3-22A0574EB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55555-80D7-4EF7-B28D-2549E65E30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0294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CC3549-5A08-B680-886F-060BC3822F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7D9254-FD41-20E4-9AFE-6A986AAE6C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D2C688-0405-073C-4C6A-0F5B6BDF4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D890C-6C35-44B3-8124-D1716A840C6B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564A4D-48B4-0F22-2119-F25ECA43A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DD58FC-B5EC-0764-6E68-F474D43483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55555-80D7-4EF7-B28D-2549E65E30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62982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1EDA7CE-263B-7983-21C8-33A2C14CF2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38C66B-B94A-ED7F-B8A9-63ED113141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C2A718-E6D3-0AC7-B1DC-3694C9AC1E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D890C-6C35-44B3-8124-D1716A840C6B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9972B3-21ED-CCD7-1412-6D8CBC9F8C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BB7781-152D-F253-3AC3-27BF131338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55555-80D7-4EF7-B28D-2549E65E30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9263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4F243A-40F8-D5F0-9689-66B38D908D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8A4CA0-CEBB-2E75-5DBD-77EC2831EC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E546E9-C971-84DB-3FCA-F12CACDD70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D890C-6C35-44B3-8124-D1716A840C6B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D3F55E-DED7-E4FB-7EAE-3233F89458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A06DAA-5793-42B5-63B0-9789668958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55555-80D7-4EF7-B28D-2549E65E30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5136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4CEE2F-B5DB-7250-CC73-325076D9EA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DCB76F-63DD-3014-8C73-D3BA3C9486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7C8BFA-3947-5442-8512-E5782553EE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D890C-6C35-44B3-8124-D1716A840C6B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A0B959-027C-9917-05E5-69FB5B8B29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0A2AFB-A468-B475-6040-75BACE6FC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55555-80D7-4EF7-B28D-2549E65E30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4232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9F8338-E175-EB2F-D368-E8C5475768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2C70DA-0E60-C0BE-3C75-9CD0ECA29AD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F489D3-52C9-5AEC-812B-1D222C7786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9734B0-67E9-4884-D457-3A8899E200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D890C-6C35-44B3-8124-D1716A840C6B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DBEC00-B56C-7E6C-8B7E-D6A57F0F5C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F9F6A0-6595-DECF-AF2B-8CF38180B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55555-80D7-4EF7-B28D-2549E65E30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1009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73B96E-72AF-1691-5E47-D533298DDD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5D9300-32AA-FD39-0636-35246C5BC8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66DEB8E-FD9B-1693-8CB2-FCA22976FC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3A0181C-6390-F2AB-A73C-C64B48D814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42896DC-7A5F-55E8-E2A7-311337E66B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F704743-255C-B04C-F77F-D6D199552A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D890C-6C35-44B3-8124-D1716A840C6B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94147AA-8ECA-4AAB-7581-488C50EE6A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7E65BA3-5298-1606-972E-A732A62AE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55555-80D7-4EF7-B28D-2549E65E30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8411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012B4E-C08C-B771-04A3-019F3DC413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30AE507-3E05-20A4-800D-1F834BE00A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D890C-6C35-44B3-8124-D1716A840C6B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2DC79A5-255C-623C-3D83-8C9E823549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18325F-8607-EDFE-800E-42CB93D70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55555-80D7-4EF7-B28D-2549E65E30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1581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7610559-F934-A2B5-A3E3-140443FD1E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D890C-6C35-44B3-8124-D1716A840C6B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0BF8507-9081-A496-72B2-7A23355784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FB7B532-5AFD-AD25-C620-ED521B434F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55555-80D7-4EF7-B28D-2549E65E30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69684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089A73-A4B4-AB17-E941-C80A3C6477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567452-CF73-C749-5664-DC026B2CB2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0EF5F0-DCB8-B145-1B4C-DC4129A3DC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84E24D-A9C8-A23B-5515-740C98584C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D890C-6C35-44B3-8124-D1716A840C6B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D2B102-C155-F9F5-4BDC-250BADD791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F45D17-CF1D-9975-6551-B461C4D409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55555-80D7-4EF7-B28D-2549E65E30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8321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322413-0B29-0F8F-8C66-F6BEDC0C4F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52657B-1A4F-0E25-48CB-310E4ECD0D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48FFB2-426F-AA81-0818-164D24F32F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8855C0-D35B-E2B5-4315-712D88FEAD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D890C-6C35-44B3-8124-D1716A840C6B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4C5B20-7322-C84F-7A2E-B2ADF24C5C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B82494-2021-CB1D-115D-8CEC67F877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55555-80D7-4EF7-B28D-2549E65E30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4296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2300A51-5BBA-1A12-9FB1-DD24B9FE93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7DB12D-0630-B4B2-30D2-B95A55E459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D4E0BC-AEE6-121E-2508-E597EE98EE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D890C-6C35-44B3-8124-D1716A840C6B}" type="datetimeFigureOut">
              <a:rPr lang="en-GB" smtClean="0"/>
              <a:t>08/1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7BD635-38A9-A1AC-14C8-D1405F84F5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094197-EFE1-A339-2080-3CD08CFB8BA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55555-80D7-4EF7-B28D-2549E65E30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72957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E594A368-76F0-D1D0-20F2-035A6D04103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55475" y="365125"/>
          <a:ext cx="4051726" cy="24633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" imgW="4462442" imgH="2712320" progId="Prism7.Document">
                  <p:embed/>
                </p:oleObj>
              </mc:Choice>
              <mc:Fallback>
                <p:oleObj name="Prism 7" r:id="rId2" imgW="4462442" imgH="2712320" progId="Prism7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E594A368-76F0-D1D0-20F2-035A6D04103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55475" y="365125"/>
                        <a:ext cx="4051726" cy="24633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873CBEA4-9E8E-B2CE-5600-839748932E6F}"/>
              </a:ext>
            </a:extLst>
          </p:cNvPr>
          <p:cNvSpPr txBox="1"/>
          <p:nvPr/>
        </p:nvSpPr>
        <p:spPr>
          <a:xfrm>
            <a:off x="655475" y="3044279"/>
            <a:ext cx="386092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</a:pPr>
            <a:r>
              <a:rPr lang="en-GB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6. The expression of CXCR6 in skin lesions correlates with PASI score.  </a:t>
            </a:r>
            <a:r>
              <a:rPr lang="en-GB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normalised read counts of CXCR6 are plotted on the y-axis and PASI scores on the x-axis. Spearman r 0.7748, p 0.04921.</a:t>
            </a:r>
          </a:p>
        </p:txBody>
      </p:sp>
    </p:spTree>
    <p:extLst>
      <p:ext uri="{BB962C8B-B14F-4D97-AF65-F5344CB8AC3E}">
        <p14:creationId xmlns:p14="http://schemas.microsoft.com/office/powerpoint/2010/main" val="963384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7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na Johnsson</dc:creator>
  <cp:lastModifiedBy>Hanna Johnsson</cp:lastModifiedBy>
  <cp:revision>1</cp:revision>
  <dcterms:created xsi:type="dcterms:W3CDTF">2022-08-11T21:10:50Z</dcterms:created>
  <dcterms:modified xsi:type="dcterms:W3CDTF">2022-11-08T12:17:41Z</dcterms:modified>
</cp:coreProperties>
</file>